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7035" autoAdjust="0"/>
  </p:normalViewPr>
  <p:slideViewPr>
    <p:cSldViewPr>
      <p:cViewPr>
        <p:scale>
          <a:sx n="107" d="100"/>
          <a:sy n="107" d="100"/>
        </p:scale>
        <p:origin x="-90" y="-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669EF-9202-43C9-94C1-9151A55343D9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444-29CC-4790-B10A-F35399E840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4232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669EF-9202-43C9-94C1-9151A55343D9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444-29CC-4790-B10A-F35399E840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5585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669EF-9202-43C9-94C1-9151A55343D9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444-29CC-4790-B10A-F35399E840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0435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669EF-9202-43C9-94C1-9151A55343D9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444-29CC-4790-B10A-F35399E840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7734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669EF-9202-43C9-94C1-9151A55343D9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444-29CC-4790-B10A-F35399E840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0908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669EF-9202-43C9-94C1-9151A55343D9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444-29CC-4790-B10A-F35399E840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8353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669EF-9202-43C9-94C1-9151A55343D9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444-29CC-4790-B10A-F35399E840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7387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669EF-9202-43C9-94C1-9151A55343D9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444-29CC-4790-B10A-F35399E840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9578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669EF-9202-43C9-94C1-9151A55343D9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444-29CC-4790-B10A-F35399E840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3898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669EF-9202-43C9-94C1-9151A55343D9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444-29CC-4790-B10A-F35399E840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54508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669EF-9202-43C9-94C1-9151A55343D9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444-29CC-4790-B10A-F35399E840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4011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669EF-9202-43C9-94C1-9151A55343D9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646444-29CC-4790-B10A-F35399E840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340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tiff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Lourdes_oct18\Foxp3creGRfl\paper\sections\Figures_271118\supplFig 271118\Fig S1a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804442"/>
            <a:ext cx="2837308" cy="21840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E:\Lourdes_oct18\Foxp3creGRfl\paper\sections\Figures_271118\supplFig 271118\Fig S1b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7608" y="3356992"/>
            <a:ext cx="6789692" cy="17281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E:\Lourdes_oct18\Foxp3creGRfl\paper\sections\Figures_271118\supplFig 271118\Fig S1c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0751" y="764704"/>
            <a:ext cx="3089561" cy="19145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hteck 3"/>
          <p:cNvSpPr/>
          <p:nvPr/>
        </p:nvSpPr>
        <p:spPr>
          <a:xfrm>
            <a:off x="179512" y="5445224"/>
            <a:ext cx="867645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hysical and functional characterization of GR deletion in Foxp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low cytometry analysis of GR expression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ymocyt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sets from Foxp3-Cre, Foxp3-C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w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Foxp3-C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analysis of GR expression in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 cells from WT, Foxp3-Cre and Foxp3-C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(left panel) and quantification afte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(right panel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ensitivity of splenic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from Foxp3-Cre and Foxp3-C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corticosterone-induced cell death as assessed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nex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/DAPI staining. Data are shown as mean ± SEM (n=3)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481014" y="826471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611253" y="315200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3929785" y="78673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</p:spTree>
    <p:extLst>
      <p:ext uri="{BB962C8B-B14F-4D97-AF65-F5344CB8AC3E}">
        <p14:creationId xmlns:p14="http://schemas.microsoft.com/office/powerpoint/2010/main" val="29107455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205415" y="3717032"/>
            <a:ext cx="849694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haracteristics of GR-deficient Foxp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low cytometry analysis of Helios expression in splenic Foxp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D44 expression (left panel) and IFN-gamma production (right panel) by TCR-activated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from Foxp3-Cre and Foxp3-C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.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control; act = TCR-activated). Data are shown as mean ± SEM (n≥3)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0" name="Picture 2" descr="E:\Lourdes_oct18\Foxp3creGRfl\paper\sections\Figures_271118\supplFig 271118\Fig S2a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1268760"/>
            <a:ext cx="2710746" cy="16706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E:\Lourdes_oct18\Foxp3creGRfl\paper\sections\Figures_271118\supplFig 271118\Fig S2b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7784" y="1147091"/>
            <a:ext cx="6625936" cy="20733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feld 2"/>
          <p:cNvSpPr txBox="1"/>
          <p:nvPr/>
        </p:nvSpPr>
        <p:spPr>
          <a:xfrm>
            <a:off x="0" y="1040243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2721278" y="104024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3954450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5696" y="692696"/>
            <a:ext cx="5281260" cy="3960945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479882" y="4509120"/>
            <a:ext cx="799288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oxp3 DNA methylation analysis in splenic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from WT, Foxp3-Cre and Foxp3-C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. Percentage of methylated reference (PMR) values were calculated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7362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395536" y="3717032"/>
            <a:ext cx="835292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plenic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xp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Foxp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number from 13 months old Foxp3-Cre and Foxp3-C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. Data are shown as mean ± SEM (n≥4)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98" name="Picture 2" descr="E:\Lourdes_oct18\Foxp3creGRfl\paper\sections\Figures_271118\supplFig 271118\Fig S4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9712" y="966216"/>
            <a:ext cx="3956304" cy="24627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058531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209842" y="4797152"/>
            <a:ext cx="8820472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ression capacity of GR-deficient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WT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62L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me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cultured either alone or co-cultured at different ratios with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Foxp3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D25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D45RB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low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derived from Foxp3-Cre or Foxp3-C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. Data are shown as mean ± SEM (n=3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litis score for mid-colon sections from RAG1-/- mice treated with WT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Foxp3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D25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D45RB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high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Tco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, either together with Foxp3-Cre or Foxp3-C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Foxp3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D25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D45RB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low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, analyzed on day 29 after cell transfer. Data are shown as mean ± SEM (n≥4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from RAG1-/- mice (treated as described 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or CD4, Foxp3, CTLA-4 and GITR expressio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ow cytometry analysis of Foxp3 expression levels of IFN-gamma producing Foxp3-Cre or Foxp3-C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from RAG1-/- mice treated as described 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Data are shown as mean ± SEM (n≥8). 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22" name="Picture 2" descr="E:\Lourdes_oct18\Foxp3creGRfl\paper\sections\Figures_271118\supplFig 271118\Fig S5a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43313" y="431742"/>
            <a:ext cx="4248472" cy="17002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E:\Lourdes_oct18\Foxp3creGRfl\paper\sections\Figures_271118\supplFig 271118\Fig S5b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27709" y="2492896"/>
            <a:ext cx="3208787" cy="21898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feld 2"/>
          <p:cNvSpPr txBox="1"/>
          <p:nvPr/>
        </p:nvSpPr>
        <p:spPr>
          <a:xfrm>
            <a:off x="131866" y="399724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4204759" y="41770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399724"/>
            <a:ext cx="3845960" cy="19993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feld 7"/>
          <p:cNvSpPr txBox="1"/>
          <p:nvPr/>
        </p:nvSpPr>
        <p:spPr>
          <a:xfrm>
            <a:off x="131866" y="2595409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5449566" y="2595408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</a:p>
        </p:txBody>
      </p:sp>
      <p:pic>
        <p:nvPicPr>
          <p:cNvPr id="1027" name="Picture 3" descr="C:\Users\q020rl\Desktop\Lourdes 2019\Foxp3cre paper revision\NEW FIGURES\Representative stainings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964" y="2903937"/>
            <a:ext cx="4786100" cy="16771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14118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q020rl\Desktop\Lourdes 2019\Foxp3cre paper revision\NEW FIGURES\additionalMarkers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3" y="116632"/>
            <a:ext cx="844568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q020rl\Desktop\Lourdes 2019\Foxp3cre paper revision\NEW FIGURES\Triple High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7" y="2533552"/>
            <a:ext cx="3999775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q020rl\Desktop\Lourdes 2019\Foxp3cre paper revision\NEW FIGURES\GITRsp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4861" y="2395052"/>
            <a:ext cx="4260971" cy="30080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203874" y="-27384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203874" y="225655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4757953" y="232326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8" name="Rechteck 7"/>
          <p:cNvSpPr/>
          <p:nvPr/>
        </p:nvSpPr>
        <p:spPr>
          <a:xfrm>
            <a:off x="323527" y="5519728"/>
            <a:ext cx="8352928" cy="13311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marker expression by </a:t>
            </a:r>
            <a:r>
              <a:rPr lang="en-US" sz="115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D4</a:t>
            </a:r>
            <a:r>
              <a:rPr lang="en-US" sz="115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15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oxp3</a:t>
            </a:r>
            <a:r>
              <a:rPr lang="en-US" sz="115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15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D45RB</a:t>
            </a:r>
            <a:r>
              <a:rPr lang="en-US" sz="115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low</a:t>
            </a:r>
            <a:r>
              <a:rPr lang="en-US" sz="115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lenocytes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eft panel: gating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hown as frequency (middle panel) and MFI (right panel) of 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</a:t>
            </a:r>
            <a:r>
              <a:rPr lang="en-US" sz="11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presentative staining of GITR </a:t>
            </a:r>
            <a:r>
              <a:rPr lang="en-US" sz="11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D-1 (upper left panel) and CD25 (upper right panel) for the characterization of GITR</a:t>
            </a:r>
            <a:r>
              <a:rPr lang="en-US" sz="11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1</a:t>
            </a:r>
            <a:r>
              <a:rPr lang="en-US" sz="11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25</a:t>
            </a:r>
            <a:r>
              <a:rPr lang="en-US" sz="11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 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ple</a:t>
            </a:r>
            <a:r>
              <a:rPr lang="en-US" sz="115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GITR</a:t>
            </a:r>
            <a:r>
              <a:rPr lang="en-US" sz="11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1</a:t>
            </a:r>
            <a:r>
              <a:rPr lang="en-US" sz="11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25</a:t>
            </a:r>
            <a:r>
              <a:rPr lang="en-US" sz="11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ple</a:t>
            </a:r>
            <a:r>
              <a:rPr lang="en-US" sz="115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5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D4</a:t>
            </a:r>
            <a:r>
              <a:rPr lang="en-US" sz="115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15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oxp3</a:t>
            </a:r>
            <a:r>
              <a:rPr lang="en-US" sz="115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15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D45RB</a:t>
            </a:r>
            <a:r>
              <a:rPr lang="en-US" sz="115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low 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sets (lower panels) from Foxp3-Cre or Foxp3-Cre 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fl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lenocytes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Gating strategy for GITR single-positive (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5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D4</a:t>
            </a:r>
            <a:r>
              <a:rPr lang="en-US" sz="115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15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oxp3</a:t>
            </a:r>
            <a:r>
              <a:rPr lang="en-US" sz="115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15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D45RB</a:t>
            </a:r>
            <a:r>
              <a:rPr lang="en-US" sz="115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low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analysis. Representative gating of Foxp3</a:t>
            </a:r>
            <a:r>
              <a:rPr lang="en-US" sz="11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upper left panel) and CD25</a:t>
            </a:r>
            <a:r>
              <a:rPr lang="en-US" sz="11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TR</a:t>
            </a:r>
            <a:r>
              <a:rPr lang="en-US" sz="11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upper right panel) 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Frequency of 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TRsp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(lower left panel) or marker expression levels (lower right panel) are indicated. Data are shown as mean ± SEM (n=3). </a:t>
            </a:r>
            <a:endParaRPr lang="de-DE" sz="11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129337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7</Words>
  <Application>Microsoft Office PowerPoint</Application>
  <PresentationFormat>Bildschirmpräsentation (4:3)</PresentationFormat>
  <Paragraphs>18</Paragraphs>
  <Slides>6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7" baseType="lpstr"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MU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ocamora Reverte Lourdes</dc:creator>
  <cp:lastModifiedBy>Rocamora Reverte Lourdes</cp:lastModifiedBy>
  <cp:revision>43</cp:revision>
  <cp:lastPrinted>2019-02-13T18:17:57Z</cp:lastPrinted>
  <dcterms:created xsi:type="dcterms:W3CDTF">2018-12-10T10:23:03Z</dcterms:created>
  <dcterms:modified xsi:type="dcterms:W3CDTF">2019-02-28T10:37:45Z</dcterms:modified>
</cp:coreProperties>
</file>